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2659" autoAdjust="0"/>
  </p:normalViewPr>
  <p:slideViewPr>
    <p:cSldViewPr snapToGrid="0" snapToObjects="1">
      <p:cViewPr>
        <p:scale>
          <a:sx n="100" d="100"/>
          <a:sy n="100" d="100"/>
        </p:scale>
        <p:origin x="-2312" y="-512"/>
      </p:cViewPr>
      <p:guideLst>
        <p:guide orient="horz" pos="243"/>
        <p:guide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01273F-F4BC-4C44-9788-34192E244855}" type="datetimeFigureOut">
              <a:rPr lang="en-US" smtClean="0"/>
              <a:t>8/5/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9F143A-5920-AB45-A74D-05287F4F46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6130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86FD56-43BD-C649-A160-981ABCB2D94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8213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8/5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982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8/5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51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8/5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116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8/5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702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8/5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560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8/5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737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8/5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38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8/5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308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8/5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376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8/5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22466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96BE3-420F-8F41-9769-130A60F9F022}" type="datetimeFigureOut">
              <a:rPr lang="en-US" smtClean="0"/>
              <a:t>8/5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008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796BE3-420F-8F41-9769-130A60F9F022}" type="datetimeFigureOut">
              <a:rPr lang="en-US" smtClean="0"/>
              <a:t>8/5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8DDB1A-797B-A449-B09E-F7DFAE71F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0785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29488" y="4366820"/>
            <a:ext cx="713114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</a:t>
            </a:r>
            <a:r>
              <a:rPr lang="en-US" sz="1400" b="1" dirty="0"/>
              <a:t>S2. Distribution of p-value and q-value of photoperiod effect on petiole </a:t>
            </a:r>
            <a:r>
              <a:rPr lang="en-US" sz="1400" b="1" dirty="0" err="1"/>
              <a:t>transcriptome</a:t>
            </a:r>
            <a:r>
              <a:rPr lang="en-US" sz="1400" b="1" dirty="0"/>
              <a:t>. </a:t>
            </a:r>
            <a:r>
              <a:rPr lang="en-US" sz="1400" dirty="0"/>
              <a:t>Raw reads from RNA sequencing were mapped to potato genome with GSNAP. Number of reads for each gene in each library were counted with </a:t>
            </a:r>
            <a:r>
              <a:rPr lang="en-US" sz="1400" dirty="0" err="1"/>
              <a:t>HTSeq</a:t>
            </a:r>
            <a:r>
              <a:rPr lang="en-US" sz="1400" dirty="0"/>
              <a:t>. The reads of all the genes identified in petiole under long day and short day treatment were normalized with upper quartile. Normalized reads were analyzed with Generalized Linear Model using </a:t>
            </a:r>
            <a:r>
              <a:rPr lang="en-US" sz="1400" dirty="0" err="1"/>
              <a:t>QLSpline</a:t>
            </a:r>
            <a:r>
              <a:rPr lang="en-US" sz="1400" dirty="0"/>
              <a:t> method in </a:t>
            </a:r>
            <a:r>
              <a:rPr lang="en-US" sz="1400" dirty="0" err="1"/>
              <a:t>QuasiSeq</a:t>
            </a:r>
            <a:r>
              <a:rPr lang="en-US" sz="1400" dirty="0"/>
              <a:t> [90].</a:t>
            </a:r>
          </a:p>
          <a:p>
            <a:endParaRPr lang="en-US" sz="1400" dirty="0"/>
          </a:p>
        </p:txBody>
      </p:sp>
      <p:grpSp>
        <p:nvGrpSpPr>
          <p:cNvPr id="8" name="Group 7"/>
          <p:cNvGrpSpPr/>
          <p:nvPr/>
        </p:nvGrpSpPr>
        <p:grpSpPr>
          <a:xfrm>
            <a:off x="1547344" y="684852"/>
            <a:ext cx="6400800" cy="3346776"/>
            <a:chOff x="1547344" y="2185432"/>
            <a:chExt cx="6400800" cy="3346776"/>
          </a:xfrm>
        </p:grpSpPr>
        <p:pic>
          <p:nvPicPr>
            <p:cNvPr id="4" name="Picture 3" descr="Pvalue.and.Q.value.from.Quasiseq.for.SD.GLM.effect.pd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657" b="13570"/>
            <a:stretch/>
          </p:blipFill>
          <p:spPr>
            <a:xfrm>
              <a:off x="1547344" y="2568496"/>
              <a:ext cx="6400800" cy="2625158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1905000" y="2199164"/>
              <a:ext cx="269005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p</a:t>
              </a:r>
              <a:r>
                <a:rPr lang="en-US" sz="1600" b="1" dirty="0" smtClean="0"/>
                <a:t>-value of photoperiod effect</a:t>
              </a:r>
              <a:endParaRPr lang="en-US" sz="1600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141804" y="2185432"/>
              <a:ext cx="269005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q-value of photoperiod effect</a:t>
              </a:r>
              <a:endParaRPr lang="en-US" sz="1600" b="1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819400" y="5193654"/>
              <a:ext cx="8197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p-value</a:t>
              </a:r>
              <a:endParaRPr lang="en-US" sz="16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108700" y="5193654"/>
              <a:ext cx="8197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q-value</a:t>
              </a:r>
              <a:endParaRPr lang="en-US" sz="1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22690050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1</TotalTime>
  <Words>104</Words>
  <Application>Microsoft Macintosh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Tian Lin</dc:creator>
  <cp:lastModifiedBy/>
  <cp:revision>23</cp:revision>
  <dcterms:created xsi:type="dcterms:W3CDTF">2014-05-27T17:03:52Z</dcterms:created>
  <dcterms:modified xsi:type="dcterms:W3CDTF">2014-08-05T21:45:39Z</dcterms:modified>
</cp:coreProperties>
</file>